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winserver16\Data\mdcrc\Research%20Server%20General\Research\NGS\NGS%20paper\Data\966%20unrelated\NGS%20consolidation%20-%20proband%20paper%20-%2096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OMD</a:t>
            </a:r>
            <a:r>
              <a:rPr lang="en-US" b="1" baseline="0"/>
              <a:t> </a:t>
            </a:r>
            <a:r>
              <a:rPr lang="en-US" b="1"/>
              <a:t>n= 100</a:t>
            </a:r>
          </a:p>
        </c:rich>
      </c:tx>
      <c:layout>
        <c:manualLayout>
          <c:xMode val="edge"/>
          <c:yMode val="edge"/>
          <c:x val="0.469598958666752"/>
          <c:y val="1.654259718775848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1229387789940902"/>
          <c:y val="0.12271298593879242"/>
          <c:w val="0.53963971576723646"/>
          <c:h val="0.82351966550086941"/>
        </c:manualLayout>
      </c:layout>
      <c:pieChart>
        <c:varyColors val="1"/>
        <c:ser>
          <c:idx val="0"/>
          <c:order val="0"/>
          <c:tx>
            <c:strRef>
              <c:f>'\\winserver16\Data\mdcrc\Research Server General\Research\NGS\Proband\[NGS consolidation - proband paper.xlsx]Working sheet'!$T$2</c:f>
              <c:strCache>
                <c:ptCount val="1"/>
                <c:pt idx="0">
                  <c:v>Total No.s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D83-4FBB-9832-FEA6C3DC576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D83-4FBB-9832-FEA6C3DC576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D83-4FBB-9832-FEA6C3DC576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D83-4FBB-9832-FEA6C3DC5763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D83-4FBB-9832-FEA6C3DC5763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D83-4FBB-9832-FEA6C3DC5763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D83-4FBB-9832-FEA6C3DC5763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D83-4FBB-9832-FEA6C3DC5763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D83-4FBB-9832-FEA6C3DC5763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BD83-4FBB-9832-FEA6C3DC5763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BD83-4FBB-9832-FEA6C3DC5763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BD83-4FBB-9832-FEA6C3DC5763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BD83-4FBB-9832-FEA6C3DC5763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BD83-4FBB-9832-FEA6C3DC5763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BD83-4FBB-9832-FEA6C3DC5763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BD83-4FBB-9832-FEA6C3DC5763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BD83-4FBB-9832-FEA6C3DC5763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BD83-4FBB-9832-FEA6C3DC5763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BD83-4FBB-9832-FEA6C3DC5763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[2]Working sheet'!$S$3:$S$21</c:f>
              <c:strCache>
                <c:ptCount val="19"/>
                <c:pt idx="0">
                  <c:v>Bethlem myopathy 1</c:v>
                </c:pt>
                <c:pt idx="1">
                  <c:v>Emery- Dreifuss Muscular Dystrophy 4</c:v>
                </c:pt>
                <c:pt idx="2">
                  <c:v>Emery- Dreifuss Muscular Dystrophy 3</c:v>
                </c:pt>
                <c:pt idx="3">
                  <c:v>Emery- Dreifuss Muscular Dystrophy 7</c:v>
                </c:pt>
                <c:pt idx="4">
                  <c:v>LGMD 1C</c:v>
                </c:pt>
                <c:pt idx="5">
                  <c:v>LGMD 1E</c:v>
                </c:pt>
                <c:pt idx="6">
                  <c:v>LGMD 2A</c:v>
                </c:pt>
                <c:pt idx="7">
                  <c:v>LGMD 2B</c:v>
                </c:pt>
                <c:pt idx="8">
                  <c:v>LGMD 2C</c:v>
                </c:pt>
                <c:pt idx="9">
                  <c:v>LGMD 2D</c:v>
                </c:pt>
                <c:pt idx="10">
                  <c:v>LGMD 2F</c:v>
                </c:pt>
                <c:pt idx="11">
                  <c:v>LGMD 2Q</c:v>
                </c:pt>
                <c:pt idx="12">
                  <c:v>LGMD 2E</c:v>
                </c:pt>
                <c:pt idx="13">
                  <c:v>LGMD Dystroglycanopathy </c:v>
                </c:pt>
                <c:pt idx="14">
                  <c:v>Megaconical Type Congenital Muscular Dystrophy</c:v>
                </c:pt>
                <c:pt idx="15">
                  <c:v>Merosin Deficient C Muscular Dystrophy type 1A</c:v>
                </c:pt>
                <c:pt idx="16">
                  <c:v>Myofibrillar myopathy 4</c:v>
                </c:pt>
                <c:pt idx="17">
                  <c:v>Ullrich Congenital Muscular Dystrophy   1</c:v>
                </c:pt>
                <c:pt idx="18">
                  <c:v>X-linked Emery Dreifuss Muscular Dystrophy 1</c:v>
                </c:pt>
              </c:strCache>
            </c:strRef>
          </c:cat>
          <c:val>
            <c:numRef>
              <c:f>'[2]Working sheet'!$T$3:$T$21</c:f>
              <c:numCache>
                <c:formatCode>General</c:formatCode>
                <c:ptCount val="19"/>
                <c:pt idx="0">
                  <c:v>2</c:v>
                </c:pt>
                <c:pt idx="1">
                  <c:v>9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1</c:v>
                </c:pt>
                <c:pt idx="7">
                  <c:v>9</c:v>
                </c:pt>
                <c:pt idx="8">
                  <c:v>6</c:v>
                </c:pt>
                <c:pt idx="9">
                  <c:v>4</c:v>
                </c:pt>
                <c:pt idx="10">
                  <c:v>1</c:v>
                </c:pt>
                <c:pt idx="11">
                  <c:v>7</c:v>
                </c:pt>
                <c:pt idx="12">
                  <c:v>28</c:v>
                </c:pt>
                <c:pt idx="13">
                  <c:v>1</c:v>
                </c:pt>
                <c:pt idx="14">
                  <c:v>1</c:v>
                </c:pt>
                <c:pt idx="15">
                  <c:v>4</c:v>
                </c:pt>
                <c:pt idx="16">
                  <c:v>1</c:v>
                </c:pt>
                <c:pt idx="17">
                  <c:v>3</c:v>
                </c:pt>
                <c:pt idx="1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BD83-4FBB-9832-FEA6C3DC57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1759623797025373E-2"/>
          <c:y val="2.488043161271505E-2"/>
          <c:w val="0.37790324989864094"/>
          <c:h val="0.97048993875765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9440565"/>
              </p:ext>
            </p:extLst>
          </p:nvPr>
        </p:nvGraphicFramePr>
        <p:xfrm>
          <a:off x="2591480" y="830308"/>
          <a:ext cx="7096125" cy="5772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933685" y="173593"/>
            <a:ext cx="4756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S4 Fig: Other Muscular Dystrophies identified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3344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7</cp:revision>
  <dcterms:created xsi:type="dcterms:W3CDTF">2020-01-14T07:41:46Z</dcterms:created>
  <dcterms:modified xsi:type="dcterms:W3CDTF">2020-01-14T07:46:06Z</dcterms:modified>
</cp:coreProperties>
</file>